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200C37-C27C-4F44-88B1-B17C4520DD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240800-743D-4012-94D6-E209277B5CC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A6BC2-26A5-4880-A99D-BF6B6861A9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5F679E-085C-4FD4-A03F-8A41C3F956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2A64BB-8BDC-472F-9A43-683225F6A6B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B94D8-EBEC-4669-A584-29F1795E38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1D67C-747B-474A-99DC-6221AFBB43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CD0B1F-859F-46F9-B3E4-6AA2D0376C9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6DEAEB-0666-4E4D-91DD-C4FCA5A70B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515B1-F1EC-4369-B5B6-AD6EC94D63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6A01E8-BCB0-4D34-B2B6-78E2D21073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78647E-F30A-4B19-BFDD-D7053522B5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0B62D6-1A8F-48CF-B3B8-A57277483DAB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3"/>
          <p:cNvSpPr/>
          <p:nvPr/>
        </p:nvSpPr>
        <p:spPr>
          <a:xfrm>
            <a:off x="1258560" y="179280"/>
            <a:ext cx="2835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Tabl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484360" y="1558800"/>
          <a:ext cx="4105440" cy="4071960"/>
        </p:xfrm>
        <a:graphic>
          <a:graphicData uri="http://schemas.openxmlformats.org/drawingml/2006/table">
            <a:tbl>
              <a:tblPr/>
              <a:tblGrid>
                <a:gridCol w="1728720"/>
                <a:gridCol w="792360"/>
                <a:gridCol w="792000"/>
                <a:gridCol w="792360"/>
              </a:tblGrid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a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K40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K41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K43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13680">
                      <a:solidFill>
                        <a:srgbClr val="000000"/>
                      </a:solidFill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48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e (year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7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ex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al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Femal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al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acroscopic findin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-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Ⅱ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oc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ize (mm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istological typ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b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i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b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 facto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1b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 factor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 facto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ymphatic invas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venous invas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NM Sta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Ⅱ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Ⅰ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Ⅲ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80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urability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ecurren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3480"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ime after operation (month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 w="9360">
                      <a:solidFill>
                        <a:srgbClr val="000000"/>
                      </a:solidFill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 w="936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936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36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テキスト ボックス 4"/>
          <p:cNvSpPr/>
          <p:nvPr/>
        </p:nvSpPr>
        <p:spPr>
          <a:xfrm>
            <a:off x="2843640" y="981000"/>
            <a:ext cx="3439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linicopathological features of 3 GC patie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nalysed on miRNA microarray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3T02:25:07Z</dcterms:created>
  <dc:creator>hirotaka</dc:creator>
  <dc:description/>
  <dc:language>en-US</dc:language>
  <cp:lastModifiedBy>hirotaka</cp:lastModifiedBy>
  <dcterms:modified xsi:type="dcterms:W3CDTF">2011-10-13T10:02:59Z</dcterms:modified>
  <cp:revision>20</cp:revision>
  <dc:subject/>
  <dc:title>スライド 1</dc:title>
</cp:coreProperties>
</file>